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23FB3B-5DEB-40E3-A55E-B0559F5D6E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0B667-4356-48DB-9552-AD84B75AEF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8BE212-2F0F-460B-B1B9-77CF80E33B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6F73D9-00C3-4129-9D62-E6C9C8E837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C2D55-10B4-435D-A09E-CAC51B5554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9CA0D-C2B8-422D-A40A-453B3AA5EF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B350F-DE2D-4CE6-AA95-ABAEF6F53A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448AA-8447-43F2-A4F7-54CD746A3E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6EEBB-7E62-492D-8A4C-2D6042C43F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9B572-660F-4D39-8887-9C93BFED8F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371ED2-42AF-4F07-A7C4-A237AD2482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5F5402-5EFA-4D65-9584-BEE574B072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F53C09-8B87-41C8-8564-0A5EBD17402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495760" y="231768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951200" y="5857920"/>
            <a:ext cx="2966760" cy="244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951200" y="5857920"/>
            <a:ext cx="2966760" cy="2444760"/>
          </a:xfrm>
          <a:prstGeom prst="rect">
            <a:avLst/>
          </a:prstGeom>
          <a:noFill/>
          <a:ln w="79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951200" y="5857920"/>
            <a:ext cx="1440" cy="2444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909800" y="830268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909800" y="805500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909800" y="781524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909800" y="7567560"/>
            <a:ext cx="414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909800" y="732960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909800" y="7080120"/>
            <a:ext cx="414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909800" y="683100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909800" y="659304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909800" y="634536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909800" y="610560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909800" y="5857920"/>
            <a:ext cx="414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951200" y="8302680"/>
            <a:ext cx="29667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1951200" y="8302320"/>
            <a:ext cx="1440" cy="50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2541600" y="8302320"/>
            <a:ext cx="1440" cy="50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V="1">
            <a:off x="3139920" y="8302320"/>
            <a:ext cx="1800" cy="50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3728880" y="8302320"/>
            <a:ext cx="1800" cy="50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4327560" y="8302320"/>
            <a:ext cx="1440" cy="50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4917960" y="8302320"/>
            <a:ext cx="1800" cy="507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951200" y="5857920"/>
            <a:ext cx="2966760" cy="2444760"/>
          </a:xfrm>
          <a:custGeom>
            <a:avLst/>
            <a:gdLst/>
            <a:ahLst/>
            <a:rect l="l" t="t" r="r" b="b"/>
            <a:pathLst>
              <a:path w="362" h="246">
                <a:moveTo>
                  <a:pt x="0" y="246"/>
                </a:moveTo>
                <a:lnTo>
                  <a:pt x="2" y="246"/>
                </a:lnTo>
                <a:lnTo>
                  <a:pt x="4" y="246"/>
                </a:lnTo>
                <a:lnTo>
                  <a:pt x="7" y="246"/>
                </a:lnTo>
                <a:lnTo>
                  <a:pt x="11" y="245"/>
                </a:lnTo>
                <a:lnTo>
                  <a:pt x="14" y="243"/>
                </a:lnTo>
                <a:lnTo>
                  <a:pt x="18" y="239"/>
                </a:lnTo>
                <a:lnTo>
                  <a:pt x="22" y="233"/>
                </a:lnTo>
                <a:lnTo>
                  <a:pt x="25" y="224"/>
                </a:lnTo>
                <a:lnTo>
                  <a:pt x="29" y="213"/>
                </a:lnTo>
                <a:lnTo>
                  <a:pt x="33" y="200"/>
                </a:lnTo>
                <a:lnTo>
                  <a:pt x="36" y="186"/>
                </a:lnTo>
                <a:lnTo>
                  <a:pt x="40" y="171"/>
                </a:lnTo>
                <a:lnTo>
                  <a:pt x="43" y="155"/>
                </a:lnTo>
                <a:lnTo>
                  <a:pt x="47" y="140"/>
                </a:lnTo>
                <a:lnTo>
                  <a:pt x="51" y="124"/>
                </a:lnTo>
                <a:lnTo>
                  <a:pt x="54" y="110"/>
                </a:lnTo>
                <a:lnTo>
                  <a:pt x="72" y="53"/>
                </a:lnTo>
                <a:lnTo>
                  <a:pt x="91" y="21"/>
                </a:lnTo>
                <a:lnTo>
                  <a:pt x="109" y="8"/>
                </a:lnTo>
                <a:lnTo>
                  <a:pt x="145" y="1"/>
                </a:lnTo>
                <a:lnTo>
                  <a:pt x="181" y="0"/>
                </a:lnTo>
                <a:lnTo>
                  <a:pt x="217" y="0"/>
                </a:lnTo>
                <a:lnTo>
                  <a:pt x="253" y="0"/>
                </a:lnTo>
                <a:lnTo>
                  <a:pt x="290" y="0"/>
                </a:lnTo>
                <a:lnTo>
                  <a:pt x="326" y="0"/>
                </a:lnTo>
                <a:lnTo>
                  <a:pt x="344" y="0"/>
                </a:lnTo>
                <a:lnTo>
                  <a:pt x="362" y="0"/>
                </a:lnTo>
              </a:path>
            </a:pathLst>
          </a:custGeom>
          <a:noFill/>
          <a:ln w="792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951200" y="8292960"/>
            <a:ext cx="1584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000160" y="829296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008080" y="829296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049480" y="8292960"/>
            <a:ext cx="1584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098800" y="8292960"/>
            <a:ext cx="1584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147760" y="829296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155680" y="829296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197080" y="828360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246400" y="827388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287440" y="8244000"/>
            <a:ext cx="1620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295360" y="8234280"/>
            <a:ext cx="1620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327400" y="8193240"/>
            <a:ext cx="25200" cy="29880"/>
          </a:xfrm>
          <a:custGeom>
            <a:avLst/>
            <a:gdLst/>
            <a:ahLst/>
            <a:rect l="l" t="t" r="r" b="b"/>
            <a:pathLst>
              <a:path w="16" h="19">
                <a:moveTo>
                  <a:pt x="0" y="13"/>
                </a:moveTo>
                <a:lnTo>
                  <a:pt x="11" y="0"/>
                </a:lnTo>
                <a:lnTo>
                  <a:pt x="16" y="7"/>
                </a:lnTo>
                <a:lnTo>
                  <a:pt x="6" y="19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368440" y="8153280"/>
            <a:ext cx="17640" cy="2088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13"/>
                </a:moveTo>
                <a:lnTo>
                  <a:pt x="5" y="0"/>
                </a:lnTo>
                <a:lnTo>
                  <a:pt x="11" y="0"/>
                </a:lnTo>
                <a:lnTo>
                  <a:pt x="5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394000" y="809460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417760" y="804528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435400" y="798516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459160" y="793584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2475000" y="7885080"/>
            <a:ext cx="17280" cy="2052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13"/>
                </a:moveTo>
                <a:lnTo>
                  <a:pt x="6" y="0"/>
                </a:lnTo>
                <a:lnTo>
                  <a:pt x="11" y="0"/>
                </a:lnTo>
                <a:lnTo>
                  <a:pt x="6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500200" y="782640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523960" y="7775640"/>
            <a:ext cx="17640" cy="2052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13"/>
                </a:moveTo>
                <a:lnTo>
                  <a:pt x="6" y="0"/>
                </a:lnTo>
                <a:lnTo>
                  <a:pt x="11" y="0"/>
                </a:lnTo>
                <a:lnTo>
                  <a:pt x="6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2541600" y="771696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2565360" y="766764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581200" y="7607160"/>
            <a:ext cx="17640" cy="19080"/>
          </a:xfrm>
          <a:custGeom>
            <a:avLst/>
            <a:gdLst/>
            <a:ahLst/>
            <a:rect l="l" t="t" r="r" b="b"/>
            <a:pathLst>
              <a:path w="11" h="12">
                <a:moveTo>
                  <a:pt x="0" y="12"/>
                </a:moveTo>
                <a:lnTo>
                  <a:pt x="6" y="0"/>
                </a:lnTo>
                <a:lnTo>
                  <a:pt x="11" y="0"/>
                </a:lnTo>
                <a:lnTo>
                  <a:pt x="6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606760" y="755820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622600" y="7497720"/>
            <a:ext cx="17280" cy="2052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6"/>
                </a:moveTo>
                <a:lnTo>
                  <a:pt x="5" y="0"/>
                </a:lnTo>
                <a:lnTo>
                  <a:pt x="11" y="6"/>
                </a:lnTo>
                <a:lnTo>
                  <a:pt x="5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647800" y="744840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2664000" y="738828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689200" y="7348680"/>
            <a:ext cx="792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689200" y="733896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705040" y="727884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7"/>
                </a:moveTo>
                <a:lnTo>
                  <a:pt x="5" y="0"/>
                </a:lnTo>
                <a:lnTo>
                  <a:pt x="10" y="7"/>
                </a:lnTo>
                <a:lnTo>
                  <a:pt x="5" y="13"/>
                </a:lnTo>
                <a:lnTo>
                  <a:pt x="0" y="7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2728800" y="7229520"/>
            <a:ext cx="17640" cy="19080"/>
          </a:xfrm>
          <a:custGeom>
            <a:avLst/>
            <a:gdLst/>
            <a:ahLst/>
            <a:rect l="l" t="t" r="r" b="b"/>
            <a:pathLst>
              <a:path w="11" h="12">
                <a:moveTo>
                  <a:pt x="0" y="12"/>
                </a:moveTo>
                <a:lnTo>
                  <a:pt x="6" y="0"/>
                </a:lnTo>
                <a:lnTo>
                  <a:pt x="11" y="0"/>
                </a:lnTo>
                <a:lnTo>
                  <a:pt x="6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754360" y="718020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770200" y="7120080"/>
            <a:ext cx="17280" cy="2052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13"/>
                </a:moveTo>
                <a:lnTo>
                  <a:pt x="5" y="0"/>
                </a:lnTo>
                <a:lnTo>
                  <a:pt x="11" y="0"/>
                </a:lnTo>
                <a:lnTo>
                  <a:pt x="5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795760" y="707076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819520" y="7010280"/>
            <a:ext cx="17280" cy="2088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6"/>
                </a:moveTo>
                <a:lnTo>
                  <a:pt x="5" y="0"/>
                </a:lnTo>
                <a:lnTo>
                  <a:pt x="11" y="6"/>
                </a:lnTo>
                <a:lnTo>
                  <a:pt x="5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2844720" y="696132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868480" y="691200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901960" y="686124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2933640" y="6811920"/>
            <a:ext cx="17640" cy="19080"/>
          </a:xfrm>
          <a:custGeom>
            <a:avLst/>
            <a:gdLst/>
            <a:ahLst/>
            <a:rect l="l" t="t" r="r" b="b"/>
            <a:pathLst>
              <a:path w="11" h="12">
                <a:moveTo>
                  <a:pt x="0" y="6"/>
                </a:moveTo>
                <a:lnTo>
                  <a:pt x="11" y="0"/>
                </a:lnTo>
                <a:lnTo>
                  <a:pt x="11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2959200" y="677232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992320" y="672300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3016080" y="6672240"/>
            <a:ext cx="1620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13"/>
                </a:moveTo>
                <a:lnTo>
                  <a:pt x="5" y="0"/>
                </a:lnTo>
                <a:lnTo>
                  <a:pt x="10" y="0"/>
                </a:lnTo>
                <a:lnTo>
                  <a:pt x="5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3049560" y="662292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073320" y="6562800"/>
            <a:ext cx="25560" cy="30240"/>
          </a:xfrm>
          <a:custGeom>
            <a:avLst/>
            <a:gdLst/>
            <a:ahLst/>
            <a:rect l="l" t="t" r="r" b="b"/>
            <a:pathLst>
              <a:path w="16" h="19">
                <a:moveTo>
                  <a:pt x="0" y="13"/>
                </a:moveTo>
                <a:lnTo>
                  <a:pt x="11" y="0"/>
                </a:lnTo>
                <a:lnTo>
                  <a:pt x="16" y="7"/>
                </a:lnTo>
                <a:lnTo>
                  <a:pt x="5" y="19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106800" y="652320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13"/>
                </a:moveTo>
                <a:lnTo>
                  <a:pt x="5" y="0"/>
                </a:lnTo>
                <a:lnTo>
                  <a:pt x="10" y="0"/>
                </a:lnTo>
                <a:lnTo>
                  <a:pt x="5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3139920" y="6473880"/>
            <a:ext cx="1620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179880" y="6443640"/>
            <a:ext cx="17280" cy="2052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13"/>
                </a:moveTo>
                <a:lnTo>
                  <a:pt x="6" y="0"/>
                </a:lnTo>
                <a:lnTo>
                  <a:pt x="11" y="0"/>
                </a:lnTo>
                <a:lnTo>
                  <a:pt x="6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3220920" y="640404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3262320" y="636444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303720" y="6324480"/>
            <a:ext cx="15840" cy="2088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335400" y="6294600"/>
            <a:ext cx="17280" cy="2052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13"/>
                </a:moveTo>
                <a:lnTo>
                  <a:pt x="6" y="0"/>
                </a:lnTo>
                <a:lnTo>
                  <a:pt x="11" y="0"/>
                </a:lnTo>
                <a:lnTo>
                  <a:pt x="6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3376440" y="6254640"/>
            <a:ext cx="17640" cy="2088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6"/>
                </a:moveTo>
                <a:lnTo>
                  <a:pt x="5" y="0"/>
                </a:lnTo>
                <a:lnTo>
                  <a:pt x="11" y="6"/>
                </a:lnTo>
                <a:lnTo>
                  <a:pt x="5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417840" y="621504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467160" y="6184800"/>
            <a:ext cx="15840" cy="2088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7"/>
                </a:moveTo>
                <a:lnTo>
                  <a:pt x="10" y="0"/>
                </a:lnTo>
                <a:lnTo>
                  <a:pt x="10" y="7"/>
                </a:lnTo>
                <a:lnTo>
                  <a:pt x="0" y="13"/>
                </a:lnTo>
                <a:lnTo>
                  <a:pt x="0" y="7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508200" y="6165720"/>
            <a:ext cx="1620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557520" y="613584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598920" y="6116760"/>
            <a:ext cx="1584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648240" y="608652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3687840" y="6056280"/>
            <a:ext cx="17280" cy="19080"/>
          </a:xfrm>
          <a:custGeom>
            <a:avLst/>
            <a:gdLst/>
            <a:ahLst/>
            <a:rect l="l" t="t" r="r" b="b"/>
            <a:pathLst>
              <a:path w="11" h="12">
                <a:moveTo>
                  <a:pt x="0" y="6"/>
                </a:moveTo>
                <a:lnTo>
                  <a:pt x="11" y="0"/>
                </a:lnTo>
                <a:lnTo>
                  <a:pt x="11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736800" y="6035760"/>
            <a:ext cx="17640" cy="2052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7"/>
                </a:moveTo>
                <a:lnTo>
                  <a:pt x="11" y="0"/>
                </a:lnTo>
                <a:lnTo>
                  <a:pt x="11" y="7"/>
                </a:lnTo>
                <a:lnTo>
                  <a:pt x="0" y="13"/>
                </a:lnTo>
                <a:lnTo>
                  <a:pt x="0" y="7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786120" y="6026040"/>
            <a:ext cx="1764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835440" y="6006960"/>
            <a:ext cx="1728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3876840" y="598644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3925800" y="5977080"/>
            <a:ext cx="1584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975120" y="5956200"/>
            <a:ext cx="15840" cy="2088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7"/>
                </a:moveTo>
                <a:lnTo>
                  <a:pt x="10" y="0"/>
                </a:lnTo>
                <a:lnTo>
                  <a:pt x="10" y="7"/>
                </a:lnTo>
                <a:lnTo>
                  <a:pt x="0" y="13"/>
                </a:lnTo>
                <a:lnTo>
                  <a:pt x="0" y="7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4024440" y="5946840"/>
            <a:ext cx="1584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073400" y="5937120"/>
            <a:ext cx="1584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122720" y="5927760"/>
            <a:ext cx="1584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172040" y="591660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221000" y="5907240"/>
            <a:ext cx="1620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4270320" y="5897520"/>
            <a:ext cx="1584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4319640" y="5886360"/>
            <a:ext cx="792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4327560" y="5886360"/>
            <a:ext cx="792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4368960" y="587700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4417920" y="5877000"/>
            <a:ext cx="1584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4467240" y="586728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4516560" y="5867280"/>
            <a:ext cx="1584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4565520" y="585792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4614840" y="5857920"/>
            <a:ext cx="792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4622760" y="5857920"/>
            <a:ext cx="792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664160" y="5857920"/>
            <a:ext cx="1584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4713120" y="5846760"/>
            <a:ext cx="1620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4762440" y="5846760"/>
            <a:ext cx="792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4770360" y="5846760"/>
            <a:ext cx="792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481176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8610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4910040" y="5846760"/>
            <a:ext cx="792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943280" y="828360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943280" y="8223120"/>
            <a:ext cx="7920" cy="208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943280" y="816444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951200" y="810432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1951200" y="804528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951200" y="798516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951200" y="7924680"/>
            <a:ext cx="7920" cy="208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959120" y="786600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959120" y="780588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959120" y="774684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967040" y="768672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1967040" y="7626240"/>
            <a:ext cx="7920" cy="208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974960" y="7567560"/>
            <a:ext cx="936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1974960" y="7507440"/>
            <a:ext cx="936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984320" y="744840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1984320" y="738828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992240" y="732960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992240" y="726912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000160" y="720900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008080" y="714996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2016000" y="708984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023920" y="7031160"/>
            <a:ext cx="97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033640" y="6980400"/>
            <a:ext cx="7920" cy="1080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2033640" y="697068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041560" y="691200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049480" y="685152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057400" y="679140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2065320" y="6732720"/>
            <a:ext cx="17640" cy="19080"/>
          </a:xfrm>
          <a:custGeom>
            <a:avLst/>
            <a:gdLst/>
            <a:ahLst/>
            <a:rect l="l" t="t" r="r" b="b"/>
            <a:pathLst>
              <a:path w="11" h="12">
                <a:moveTo>
                  <a:pt x="0" y="12"/>
                </a:moveTo>
                <a:lnTo>
                  <a:pt x="5" y="0"/>
                </a:lnTo>
                <a:lnTo>
                  <a:pt x="11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2082960" y="6672240"/>
            <a:ext cx="7920" cy="205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2090880" y="661356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12"/>
                </a:moveTo>
                <a:lnTo>
                  <a:pt x="5" y="0"/>
                </a:lnTo>
                <a:lnTo>
                  <a:pt x="10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2106720" y="6553080"/>
            <a:ext cx="15840" cy="2088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13"/>
                </a:moveTo>
                <a:lnTo>
                  <a:pt x="5" y="0"/>
                </a:lnTo>
                <a:lnTo>
                  <a:pt x="10" y="0"/>
                </a:lnTo>
                <a:lnTo>
                  <a:pt x="5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2122560" y="6492960"/>
            <a:ext cx="17280" cy="20520"/>
          </a:xfrm>
          <a:custGeom>
            <a:avLst/>
            <a:gdLst/>
            <a:ahLst/>
            <a:rect l="l" t="t" r="r" b="b"/>
            <a:pathLst>
              <a:path w="11" h="13">
                <a:moveTo>
                  <a:pt x="0" y="13"/>
                </a:moveTo>
                <a:lnTo>
                  <a:pt x="6" y="0"/>
                </a:lnTo>
                <a:lnTo>
                  <a:pt x="11" y="0"/>
                </a:lnTo>
                <a:lnTo>
                  <a:pt x="6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2139840" y="6434280"/>
            <a:ext cx="7920" cy="1908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155680" y="6373800"/>
            <a:ext cx="1620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13"/>
                </a:moveTo>
                <a:lnTo>
                  <a:pt x="5" y="0"/>
                </a:lnTo>
                <a:lnTo>
                  <a:pt x="10" y="0"/>
                </a:lnTo>
                <a:lnTo>
                  <a:pt x="5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181240" y="632448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181240" y="630540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205000" y="6254640"/>
            <a:ext cx="15840" cy="2088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13"/>
                </a:moveTo>
                <a:lnTo>
                  <a:pt x="5" y="0"/>
                </a:lnTo>
                <a:lnTo>
                  <a:pt x="10" y="0"/>
                </a:lnTo>
                <a:lnTo>
                  <a:pt x="5" y="13"/>
                </a:lnTo>
                <a:lnTo>
                  <a:pt x="0" y="13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2220840" y="6195960"/>
            <a:ext cx="17640" cy="19080"/>
          </a:xfrm>
          <a:custGeom>
            <a:avLst/>
            <a:gdLst/>
            <a:ahLst/>
            <a:rect l="l" t="t" r="r" b="b"/>
            <a:pathLst>
              <a:path w="11" h="12">
                <a:moveTo>
                  <a:pt x="0" y="12"/>
                </a:moveTo>
                <a:lnTo>
                  <a:pt x="5" y="0"/>
                </a:lnTo>
                <a:lnTo>
                  <a:pt x="11" y="0"/>
                </a:lnTo>
                <a:lnTo>
                  <a:pt x="5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246400" y="6135840"/>
            <a:ext cx="15840" cy="2052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278080" y="6086520"/>
            <a:ext cx="17280" cy="19080"/>
          </a:xfrm>
          <a:custGeom>
            <a:avLst/>
            <a:gdLst/>
            <a:ahLst/>
            <a:rect l="l" t="t" r="r" b="b"/>
            <a:pathLst>
              <a:path w="11" h="12">
                <a:moveTo>
                  <a:pt x="0" y="12"/>
                </a:moveTo>
                <a:lnTo>
                  <a:pt x="6" y="0"/>
                </a:lnTo>
                <a:lnTo>
                  <a:pt x="11" y="0"/>
                </a:lnTo>
                <a:lnTo>
                  <a:pt x="6" y="12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311560" y="6026040"/>
            <a:ext cx="15840" cy="2088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6"/>
                </a:moveTo>
                <a:lnTo>
                  <a:pt x="5" y="0"/>
                </a:lnTo>
                <a:lnTo>
                  <a:pt x="10" y="6"/>
                </a:lnTo>
                <a:lnTo>
                  <a:pt x="5" y="13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344680" y="5977080"/>
            <a:ext cx="23760" cy="29880"/>
          </a:xfrm>
          <a:custGeom>
            <a:avLst/>
            <a:gdLst/>
            <a:ahLst/>
            <a:rect l="l" t="t" r="r" b="b"/>
            <a:pathLst>
              <a:path w="15" h="19">
                <a:moveTo>
                  <a:pt x="0" y="12"/>
                </a:moveTo>
                <a:lnTo>
                  <a:pt x="10" y="0"/>
                </a:lnTo>
                <a:lnTo>
                  <a:pt x="15" y="6"/>
                </a:lnTo>
                <a:lnTo>
                  <a:pt x="5" y="19"/>
                </a:lnTo>
                <a:lnTo>
                  <a:pt x="0" y="12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16920" bIns="-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394000" y="5937120"/>
            <a:ext cx="15840" cy="19080"/>
          </a:xfrm>
          <a:custGeom>
            <a:avLst/>
            <a:gdLst/>
            <a:ahLst/>
            <a:rect l="l" t="t" r="r" b="b"/>
            <a:pathLst>
              <a:path w="10" h="12">
                <a:moveTo>
                  <a:pt x="0" y="6"/>
                </a:moveTo>
                <a:lnTo>
                  <a:pt x="10" y="0"/>
                </a:lnTo>
                <a:lnTo>
                  <a:pt x="10" y="6"/>
                </a:lnTo>
                <a:lnTo>
                  <a:pt x="0" y="12"/>
                </a:lnTo>
                <a:lnTo>
                  <a:pt x="0" y="6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443320" y="591660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2484360" y="5886360"/>
            <a:ext cx="15840" cy="20880"/>
          </a:xfrm>
          <a:custGeom>
            <a:avLst/>
            <a:gdLst/>
            <a:ahLst/>
            <a:rect l="l" t="t" r="r" b="b"/>
            <a:pathLst>
              <a:path w="10" h="13">
                <a:moveTo>
                  <a:pt x="0" y="7"/>
                </a:moveTo>
                <a:lnTo>
                  <a:pt x="10" y="0"/>
                </a:lnTo>
                <a:lnTo>
                  <a:pt x="10" y="7"/>
                </a:lnTo>
                <a:lnTo>
                  <a:pt x="0" y="13"/>
                </a:lnTo>
                <a:lnTo>
                  <a:pt x="0" y="7"/>
                </a:lnTo>
                <a:close/>
              </a:path>
            </a:pathLst>
          </a:cu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533680" y="586728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2541600" y="5867280"/>
            <a:ext cx="7920" cy="972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2581200" y="5857920"/>
            <a:ext cx="1764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2630520" y="5857920"/>
            <a:ext cx="17280" cy="93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267984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2728800" y="5846760"/>
            <a:ext cx="176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2778120" y="5846760"/>
            <a:ext cx="176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282744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876400" y="5846760"/>
            <a:ext cx="176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2925720" y="5846760"/>
            <a:ext cx="176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297504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302436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3073320" y="5846760"/>
            <a:ext cx="176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312264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317196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322092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327024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331956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3368520" y="5846760"/>
            <a:ext cx="1620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341784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346716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35164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56544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361476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36640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371304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376236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38116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860640" y="5846760"/>
            <a:ext cx="1620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390996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39592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400860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405756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41068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415620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420516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42544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430380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4352760" y="5846760"/>
            <a:ext cx="1620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44020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445140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450072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4549680" y="5846760"/>
            <a:ext cx="158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459756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4646520" y="5846760"/>
            <a:ext cx="176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469584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474516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4794120" y="5846760"/>
            <a:ext cx="176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4843440" y="5846760"/>
            <a:ext cx="1764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4892760" y="5846760"/>
            <a:ext cx="17280" cy="11160"/>
          </a:xfrm>
          <a:prstGeom prst="rect">
            <a:avLst/>
          </a:prstGeom>
          <a:solidFill>
            <a:srgbClr val="808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1917720" y="8263080"/>
            <a:ext cx="6660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1935000" y="826308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1951200" y="8263080"/>
            <a:ext cx="6480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1974960" y="8263080"/>
            <a:ext cx="6660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2008080" y="8253360"/>
            <a:ext cx="6516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2033640" y="8234280"/>
            <a:ext cx="6516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2065320" y="8193240"/>
            <a:ext cx="66600" cy="8064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2098800" y="8134200"/>
            <a:ext cx="6480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2122560" y="8045280"/>
            <a:ext cx="6660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2155680" y="7935840"/>
            <a:ext cx="6516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2189160" y="780588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2212920" y="766764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2246400" y="7518240"/>
            <a:ext cx="6516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2270160" y="7358040"/>
            <a:ext cx="6660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2303640" y="7209000"/>
            <a:ext cx="64800" cy="8064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800" bIns="10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2336760" y="705024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2360520" y="691200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2508120" y="634536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2664000" y="6026040"/>
            <a:ext cx="6480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2811600" y="5897520"/>
            <a:ext cx="6480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3106800" y="5827680"/>
            <a:ext cx="65160" cy="7956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720" bIns="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3402000" y="581832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3697200" y="581832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3990960" y="5818320"/>
            <a:ext cx="6660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4294080" y="5818320"/>
            <a:ext cx="669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4589640" y="5818320"/>
            <a:ext cx="6660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4737240" y="5818320"/>
            <a:ext cx="6660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4884840" y="5818320"/>
            <a:ext cx="65160" cy="79200"/>
          </a:xfrm>
          <a:prstGeom prst="ellipse">
            <a:avLst/>
          </a:prstGeom>
          <a:solidFill>
            <a:srgbClr val="000080"/>
          </a:solidFill>
          <a:ln w="792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360" bIns="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1917720" y="826308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1935000" y="826308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1951200" y="8263080"/>
            <a:ext cx="6480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1974960" y="826308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2008080" y="826308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2033640" y="826308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2065320" y="826308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2098800" y="8263080"/>
            <a:ext cx="6480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2122560" y="826308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2155680" y="826308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2189160" y="825336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2212920" y="825336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2246400" y="823428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2270160" y="821376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2303640" y="8183520"/>
            <a:ext cx="6480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2336760" y="814392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2360520" y="809460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2508120" y="772632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2664000" y="7308720"/>
            <a:ext cx="6480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2811600" y="6951600"/>
            <a:ext cx="6480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3106800" y="646416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3402000" y="618480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3697200" y="601668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3990960" y="5916600"/>
            <a:ext cx="66600" cy="7956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4294080" y="5857920"/>
            <a:ext cx="6696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4589640" y="5827680"/>
            <a:ext cx="66600" cy="7956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4737240" y="581832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4884840" y="581832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1917720" y="826308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1935000" y="772632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1951200" y="7488360"/>
            <a:ext cx="6480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1974960" y="7169040"/>
            <a:ext cx="66600" cy="7956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2008080" y="694044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033640" y="675180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2065320" y="6602400"/>
            <a:ext cx="66600" cy="7956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2098800" y="6483240"/>
            <a:ext cx="6480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2122560" y="6373800"/>
            <a:ext cx="66600" cy="7956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2155680" y="628488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2189160" y="620568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2212920" y="613584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2246400" y="6075360"/>
            <a:ext cx="65160" cy="81000"/>
          </a:xfrm>
          <a:custGeom>
            <a:avLst/>
            <a:gdLst/>
            <a:ahLst/>
            <a:rect l="l" t="t" r="r" b="b"/>
            <a:pathLst>
              <a:path w="41" h="51">
                <a:moveTo>
                  <a:pt x="20" y="0"/>
                </a:moveTo>
                <a:lnTo>
                  <a:pt x="41" y="26"/>
                </a:lnTo>
                <a:lnTo>
                  <a:pt x="20" y="51"/>
                </a:lnTo>
                <a:lnTo>
                  <a:pt x="0" y="26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2270160" y="6026040"/>
            <a:ext cx="66600" cy="7956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2303640" y="5986440"/>
            <a:ext cx="6480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2336760" y="594684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2360520" y="5916600"/>
            <a:ext cx="65160" cy="7956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2508120" y="583740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2664000" y="5818320"/>
            <a:ext cx="6480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2811600" y="5818320"/>
            <a:ext cx="6480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3106800" y="581832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3402000" y="581832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3697200" y="581832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0" y="0"/>
                </a:moveTo>
                <a:lnTo>
                  <a:pt x="41" y="25"/>
                </a:lnTo>
                <a:lnTo>
                  <a:pt x="20" y="50"/>
                </a:lnTo>
                <a:lnTo>
                  <a:pt x="0" y="25"/>
                </a:lnTo>
                <a:lnTo>
                  <a:pt x="20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990960" y="581832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4294080" y="5818320"/>
            <a:ext cx="6696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4589640" y="581832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4737240" y="5818320"/>
            <a:ext cx="66600" cy="79200"/>
          </a:xfrm>
          <a:custGeom>
            <a:avLst/>
            <a:gdLst/>
            <a:ahLst/>
            <a:rect l="l" t="t" r="r" b="b"/>
            <a:pathLst>
              <a:path w="42" h="50">
                <a:moveTo>
                  <a:pt x="21" y="0"/>
                </a:moveTo>
                <a:lnTo>
                  <a:pt x="42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4884840" y="5818320"/>
            <a:ext cx="65160" cy="79200"/>
          </a:xfrm>
          <a:custGeom>
            <a:avLst/>
            <a:gdLst/>
            <a:ahLst/>
            <a:rect l="l" t="t" r="r" b="b"/>
            <a:pathLst>
              <a:path w="41" h="50">
                <a:moveTo>
                  <a:pt x="21" y="0"/>
                </a:moveTo>
                <a:lnTo>
                  <a:pt x="41" y="25"/>
                </a:lnTo>
                <a:lnTo>
                  <a:pt x="21" y="50"/>
                </a:lnTo>
                <a:lnTo>
                  <a:pt x="0" y="25"/>
                </a:lnTo>
                <a:lnTo>
                  <a:pt x="21" y="0"/>
                </a:lnTo>
                <a:close/>
              </a:path>
            </a:pathLst>
          </a:custGeom>
          <a:solidFill>
            <a:srgbClr val="808080"/>
          </a:solidFill>
          <a:ln w="792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1770120" y="8213760"/>
            <a:ext cx="92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1656000" y="796464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1656000" y="772632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1656000" y="747864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3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1656000" y="723888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1656000" y="699120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1656000" y="674208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1656000" y="650412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7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1656000" y="625464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1656000" y="601668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9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1770120" y="5767560"/>
            <a:ext cx="92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1917720" y="8462880"/>
            <a:ext cx="92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2451600" y="846288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3049920" y="846288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3638880" y="846288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4237560" y="8462880"/>
            <a:ext cx="229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4884840" y="8462880"/>
            <a:ext cx="9216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2735280" y="8759880"/>
            <a:ext cx="173808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False positive fraction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 rot="16200000">
            <a:off x="646200" y="6831360"/>
            <a:ext cx="167400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Arial"/>
              </a:rPr>
              <a:t>True positive fraction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9" name=""/>
          <p:cNvGrpSpPr/>
          <p:nvPr/>
        </p:nvGrpSpPr>
        <p:grpSpPr>
          <a:xfrm>
            <a:off x="1312920" y="488880"/>
            <a:ext cx="4447080" cy="3508200"/>
            <a:chOff x="1312920" y="488880"/>
            <a:chExt cx="4447080" cy="3508200"/>
          </a:xfrm>
        </p:grpSpPr>
        <p:sp>
          <p:nvSpPr>
            <p:cNvPr id="350" name=""/>
            <p:cNvSpPr/>
            <p:nvPr/>
          </p:nvSpPr>
          <p:spPr>
            <a:xfrm>
              <a:off x="1882800" y="958680"/>
              <a:ext cx="2924280" cy="2397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1882800" y="958680"/>
              <a:ext cx="2924280" cy="2397240"/>
            </a:xfrm>
            <a:prstGeom prst="rect">
              <a:avLst/>
            </a:prstGeom>
            <a:noFill/>
            <a:ln w="792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882800" y="958680"/>
              <a:ext cx="1440" cy="2397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1843200" y="3355920"/>
              <a:ext cx="39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1843200" y="3111480"/>
              <a:ext cx="39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1843200" y="2878200"/>
              <a:ext cx="39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1843200" y="2633760"/>
              <a:ext cx="39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1843200" y="2400480"/>
              <a:ext cx="39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1843200" y="2157480"/>
              <a:ext cx="39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1843200" y="1913040"/>
              <a:ext cx="3960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1843200" y="1679400"/>
              <a:ext cx="39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1843200" y="1434960"/>
              <a:ext cx="39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1843200" y="1201680"/>
              <a:ext cx="39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1843200" y="958680"/>
              <a:ext cx="396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1882800" y="3355920"/>
              <a:ext cx="2924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 flipV="1">
              <a:off x="1882800" y="3355920"/>
              <a:ext cx="144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 flipV="1">
              <a:off x="2463840" y="3355920"/>
              <a:ext cx="144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 flipV="1">
              <a:off x="3054240" y="3355920"/>
              <a:ext cx="180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 flipV="1">
              <a:off x="3635280" y="3355920"/>
              <a:ext cx="180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 flipV="1">
              <a:off x="4226040" y="3355920"/>
              <a:ext cx="144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 flipV="1">
              <a:off x="4807080" y="3355920"/>
              <a:ext cx="144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1882800" y="958680"/>
              <a:ext cx="2924280" cy="2397240"/>
            </a:xfrm>
            <a:custGeom>
              <a:avLst/>
              <a:gdLst/>
              <a:ahLst/>
              <a:rect l="l" t="t" r="r" b="b"/>
              <a:pathLst>
                <a:path w="362" h="246">
                  <a:moveTo>
                    <a:pt x="0" y="246"/>
                  </a:moveTo>
                  <a:lnTo>
                    <a:pt x="2" y="226"/>
                  </a:lnTo>
                  <a:lnTo>
                    <a:pt x="4" y="214"/>
                  </a:lnTo>
                  <a:lnTo>
                    <a:pt x="7" y="197"/>
                  </a:lnTo>
                  <a:lnTo>
                    <a:pt x="11" y="184"/>
                  </a:lnTo>
                  <a:lnTo>
                    <a:pt x="14" y="173"/>
                  </a:lnTo>
                  <a:lnTo>
                    <a:pt x="18" y="164"/>
                  </a:lnTo>
                  <a:lnTo>
                    <a:pt x="22" y="155"/>
                  </a:lnTo>
                  <a:lnTo>
                    <a:pt x="25" y="148"/>
                  </a:lnTo>
                  <a:lnTo>
                    <a:pt x="29" y="141"/>
                  </a:lnTo>
                  <a:lnTo>
                    <a:pt x="33" y="134"/>
                  </a:lnTo>
                  <a:lnTo>
                    <a:pt x="36" y="128"/>
                  </a:lnTo>
                  <a:lnTo>
                    <a:pt x="40" y="123"/>
                  </a:lnTo>
                  <a:lnTo>
                    <a:pt x="43" y="118"/>
                  </a:lnTo>
                  <a:lnTo>
                    <a:pt x="47" y="113"/>
                  </a:lnTo>
                  <a:lnTo>
                    <a:pt x="51" y="108"/>
                  </a:lnTo>
                  <a:lnTo>
                    <a:pt x="54" y="104"/>
                  </a:lnTo>
                  <a:lnTo>
                    <a:pt x="72" y="85"/>
                  </a:lnTo>
                  <a:lnTo>
                    <a:pt x="91" y="70"/>
                  </a:lnTo>
                  <a:lnTo>
                    <a:pt x="109" y="57"/>
                  </a:lnTo>
                  <a:lnTo>
                    <a:pt x="145" y="39"/>
                  </a:lnTo>
                  <a:lnTo>
                    <a:pt x="181" y="25"/>
                  </a:lnTo>
                  <a:lnTo>
                    <a:pt x="217" y="16"/>
                  </a:lnTo>
                  <a:lnTo>
                    <a:pt x="253" y="9"/>
                  </a:lnTo>
                  <a:lnTo>
                    <a:pt x="290" y="4"/>
                  </a:lnTo>
                  <a:lnTo>
                    <a:pt x="326" y="1"/>
                  </a:lnTo>
                  <a:lnTo>
                    <a:pt x="344" y="0"/>
                  </a:lnTo>
                  <a:lnTo>
                    <a:pt x="362" y="0"/>
                  </a:lnTo>
                </a:path>
              </a:pathLst>
            </a:custGeom>
            <a:noFill/>
            <a:ln w="792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1882800" y="333540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1924200" y="32972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1955880" y="32576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1979640" y="320832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5" y="0"/>
                  </a:lnTo>
                  <a:lnTo>
                    <a:pt x="10" y="7"/>
                  </a:lnTo>
                  <a:lnTo>
                    <a:pt x="5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1987560" y="319896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2011320" y="3160800"/>
              <a:ext cx="1764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12"/>
                  </a:moveTo>
                  <a:lnTo>
                    <a:pt x="6" y="0"/>
                  </a:lnTo>
                  <a:lnTo>
                    <a:pt x="11" y="0"/>
                  </a:lnTo>
                  <a:lnTo>
                    <a:pt x="6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2044800" y="31114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2068560" y="305280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2076480" y="30430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2100240" y="3005280"/>
              <a:ext cx="1764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6"/>
                  </a:moveTo>
                  <a:lnTo>
                    <a:pt x="6" y="0"/>
                  </a:lnTo>
                  <a:lnTo>
                    <a:pt x="11" y="6"/>
                  </a:lnTo>
                  <a:lnTo>
                    <a:pt x="6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2109960" y="299412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5" y="0"/>
                  </a:lnTo>
                  <a:lnTo>
                    <a:pt x="10" y="7"/>
                  </a:lnTo>
                  <a:lnTo>
                    <a:pt x="5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2133720" y="29559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2157480" y="28972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2165400" y="28875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2189160" y="2847960"/>
              <a:ext cx="17640" cy="2052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7"/>
                  </a:moveTo>
                  <a:lnTo>
                    <a:pt x="6" y="0"/>
                  </a:lnTo>
                  <a:lnTo>
                    <a:pt x="11" y="7"/>
                  </a:lnTo>
                  <a:lnTo>
                    <a:pt x="6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2198520" y="2838600"/>
              <a:ext cx="1620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2222640" y="279072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2254320" y="2732040"/>
              <a:ext cx="23760" cy="28800"/>
            </a:xfrm>
            <a:custGeom>
              <a:avLst/>
              <a:gdLst/>
              <a:ahLst/>
              <a:rect l="l" t="t" r="r" b="b"/>
              <a:pathLst>
                <a:path w="15" h="18">
                  <a:moveTo>
                    <a:pt x="0" y="12"/>
                  </a:moveTo>
                  <a:lnTo>
                    <a:pt x="10" y="0"/>
                  </a:lnTo>
                  <a:lnTo>
                    <a:pt x="15" y="6"/>
                  </a:lnTo>
                  <a:lnTo>
                    <a:pt x="5" y="18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2295360" y="2692440"/>
              <a:ext cx="1620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2327400" y="263376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2351160" y="2585880"/>
              <a:ext cx="23760" cy="28800"/>
            </a:xfrm>
            <a:custGeom>
              <a:avLst/>
              <a:gdLst/>
              <a:ahLst/>
              <a:rect l="l" t="t" r="r" b="b"/>
              <a:pathLst>
                <a:path w="15" h="18">
                  <a:moveTo>
                    <a:pt x="0" y="12"/>
                  </a:moveTo>
                  <a:lnTo>
                    <a:pt x="10" y="0"/>
                  </a:lnTo>
                  <a:lnTo>
                    <a:pt x="15" y="6"/>
                  </a:lnTo>
                  <a:lnTo>
                    <a:pt x="5" y="18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2392200" y="2546280"/>
              <a:ext cx="1620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2424240" y="2496960"/>
              <a:ext cx="15840" cy="2088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10" y="0"/>
                  </a:lnTo>
                  <a:lnTo>
                    <a:pt x="10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2448000" y="24591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2455920" y="24494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2489040" y="2419200"/>
              <a:ext cx="16200" cy="2088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13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3"/>
                  </a:lnTo>
                  <a:lnTo>
                    <a:pt x="0" y="13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2521080" y="2371680"/>
              <a:ext cx="23760" cy="28800"/>
            </a:xfrm>
            <a:custGeom>
              <a:avLst/>
              <a:gdLst/>
              <a:ahLst/>
              <a:rect l="l" t="t" r="r" b="b"/>
              <a:pathLst>
                <a:path w="15" h="18">
                  <a:moveTo>
                    <a:pt x="0" y="12"/>
                  </a:moveTo>
                  <a:lnTo>
                    <a:pt x="10" y="0"/>
                  </a:lnTo>
                  <a:lnTo>
                    <a:pt x="15" y="6"/>
                  </a:lnTo>
                  <a:lnTo>
                    <a:pt x="5" y="18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2560680" y="2332080"/>
              <a:ext cx="1728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6"/>
                  </a:moveTo>
                  <a:lnTo>
                    <a:pt x="6" y="0"/>
                  </a:lnTo>
                  <a:lnTo>
                    <a:pt x="11" y="6"/>
                  </a:lnTo>
                  <a:lnTo>
                    <a:pt x="6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2602080" y="229248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10" y="0"/>
                  </a:lnTo>
                  <a:lnTo>
                    <a:pt x="10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2641680" y="2254320"/>
              <a:ext cx="1728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6"/>
                  </a:moveTo>
                  <a:lnTo>
                    <a:pt x="11" y="0"/>
                  </a:lnTo>
                  <a:lnTo>
                    <a:pt x="11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2674800" y="221472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5" y="0"/>
                  </a:lnTo>
                  <a:lnTo>
                    <a:pt x="10" y="7"/>
                  </a:lnTo>
                  <a:lnTo>
                    <a:pt x="5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2714760" y="218592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2746440" y="2146320"/>
              <a:ext cx="17280" cy="2052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7"/>
                  </a:moveTo>
                  <a:lnTo>
                    <a:pt x="6" y="0"/>
                  </a:lnTo>
                  <a:lnTo>
                    <a:pt x="11" y="7"/>
                  </a:lnTo>
                  <a:lnTo>
                    <a:pt x="6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2755800" y="2136600"/>
              <a:ext cx="15840" cy="2088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2795760" y="21081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2835360" y="2077920"/>
              <a:ext cx="17280" cy="2088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7"/>
                  </a:moveTo>
                  <a:lnTo>
                    <a:pt x="11" y="0"/>
                  </a:lnTo>
                  <a:lnTo>
                    <a:pt x="11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2876400" y="2049480"/>
              <a:ext cx="1620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2916360" y="200988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5" y="0"/>
                  </a:lnTo>
                  <a:lnTo>
                    <a:pt x="10" y="7"/>
                  </a:lnTo>
                  <a:lnTo>
                    <a:pt x="5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2965320" y="19810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3005280" y="19526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3038400" y="1922400"/>
              <a:ext cx="15840" cy="2088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3054240" y="1922400"/>
              <a:ext cx="792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3086280" y="18939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3135240" y="186372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10" y="0"/>
                  </a:lnTo>
                  <a:lnTo>
                    <a:pt x="10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3174840" y="1835280"/>
              <a:ext cx="1620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3224160" y="181620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3263760" y="178596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3305160" y="1757520"/>
              <a:ext cx="15840" cy="1872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3352680" y="17384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3402000" y="171756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3441600" y="168912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3490920" y="16700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3538440" y="164952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10" y="0"/>
                  </a:lnTo>
                  <a:lnTo>
                    <a:pt x="10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3579840" y="16304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3627360" y="1611360"/>
              <a:ext cx="792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3635280" y="1611360"/>
              <a:ext cx="792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3676680" y="159228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3716280" y="157176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3765600" y="15429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3813120" y="15238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3854520" y="150336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3902040" y="14842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3951360" y="147492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3998880" y="145584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4048200" y="1434960"/>
              <a:ext cx="15840" cy="2088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4087800" y="14158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4137120" y="140652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4184640" y="138744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4233960" y="136692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10" y="0"/>
                  </a:lnTo>
                  <a:lnTo>
                    <a:pt x="10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4281480" y="13478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4322880" y="13287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4370400" y="130968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4419720" y="128916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4459320" y="127008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4508640" y="1251000"/>
              <a:ext cx="792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4516560" y="1251000"/>
              <a:ext cx="792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4556160" y="122076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4597560" y="12016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4645080" y="118260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4668840" y="1133640"/>
              <a:ext cx="25560" cy="28440"/>
            </a:xfrm>
            <a:custGeom>
              <a:avLst/>
              <a:gdLst/>
              <a:ahLst/>
              <a:rect l="l" t="t" r="r" b="b"/>
              <a:pathLst>
                <a:path w="16" h="18">
                  <a:moveTo>
                    <a:pt x="0" y="12"/>
                  </a:moveTo>
                  <a:lnTo>
                    <a:pt x="11" y="0"/>
                  </a:lnTo>
                  <a:lnTo>
                    <a:pt x="16" y="6"/>
                  </a:lnTo>
                  <a:lnTo>
                    <a:pt x="5" y="18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4702320" y="1093680"/>
              <a:ext cx="15840" cy="2088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13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3"/>
                  </a:lnTo>
                  <a:lnTo>
                    <a:pt x="0" y="13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4734000" y="10461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4757760" y="996840"/>
              <a:ext cx="1728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6"/>
                  </a:moveTo>
                  <a:lnTo>
                    <a:pt x="5" y="0"/>
                  </a:lnTo>
                  <a:lnTo>
                    <a:pt x="11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4791240" y="9586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1874880" y="3335400"/>
              <a:ext cx="7920" cy="205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1874880" y="3276720"/>
              <a:ext cx="7920" cy="205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1874880" y="321948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>
              <a:off x="1874880" y="316080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1874880" y="310212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1874880" y="304308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1882800" y="2984400"/>
              <a:ext cx="7920" cy="208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1882800" y="2925720"/>
              <a:ext cx="7920" cy="205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1882800" y="286848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1882800" y="280980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1882800" y="275112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1882800" y="269244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1882800" y="2633760"/>
              <a:ext cx="7920" cy="205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1882800" y="257652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1882800" y="251784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1882800" y="245916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1882800" y="2400480"/>
              <a:ext cx="15840" cy="1872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1890720" y="234144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1890720" y="2282760"/>
              <a:ext cx="7920" cy="208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1890720" y="222552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1890720" y="216684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1890720" y="210816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1890720" y="20494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1898640" y="199080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1906560" y="1932120"/>
              <a:ext cx="17640" cy="2052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13"/>
                  </a:moveTo>
                  <a:lnTo>
                    <a:pt x="5" y="0"/>
                  </a:lnTo>
                  <a:lnTo>
                    <a:pt x="11" y="0"/>
                  </a:lnTo>
                  <a:lnTo>
                    <a:pt x="5" y="13"/>
                  </a:lnTo>
                  <a:lnTo>
                    <a:pt x="0" y="13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1924200" y="1874880"/>
              <a:ext cx="7920" cy="19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1940040" y="181620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12"/>
                  </a:moveTo>
                  <a:lnTo>
                    <a:pt x="5" y="0"/>
                  </a:lnTo>
                  <a:lnTo>
                    <a:pt x="10" y="0"/>
                  </a:lnTo>
                  <a:lnTo>
                    <a:pt x="5" y="12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1963800" y="1766880"/>
              <a:ext cx="792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1963800" y="174780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1987560" y="1708200"/>
              <a:ext cx="792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1987560" y="168912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2011320" y="1649520"/>
              <a:ext cx="17640" cy="2052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13"/>
                  </a:moveTo>
                  <a:lnTo>
                    <a:pt x="6" y="0"/>
                  </a:lnTo>
                  <a:lnTo>
                    <a:pt x="11" y="0"/>
                  </a:lnTo>
                  <a:lnTo>
                    <a:pt x="6" y="13"/>
                  </a:lnTo>
                  <a:lnTo>
                    <a:pt x="0" y="13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2044800" y="160164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2052720" y="15922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2076480" y="1542960"/>
              <a:ext cx="23760" cy="28800"/>
            </a:xfrm>
            <a:custGeom>
              <a:avLst/>
              <a:gdLst/>
              <a:ahLst/>
              <a:rect l="l" t="t" r="r" b="b"/>
              <a:pathLst>
                <a:path w="15" h="18">
                  <a:moveTo>
                    <a:pt x="0" y="12"/>
                  </a:moveTo>
                  <a:lnTo>
                    <a:pt x="10" y="0"/>
                  </a:lnTo>
                  <a:lnTo>
                    <a:pt x="15" y="6"/>
                  </a:lnTo>
                  <a:lnTo>
                    <a:pt x="5" y="18"/>
                  </a:lnTo>
                  <a:lnTo>
                    <a:pt x="0" y="12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2117880" y="150336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2157480" y="146520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2189160" y="1434960"/>
              <a:ext cx="17640" cy="2088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6"/>
                  </a:moveTo>
                  <a:lnTo>
                    <a:pt x="6" y="0"/>
                  </a:lnTo>
                  <a:lnTo>
                    <a:pt x="11" y="6"/>
                  </a:lnTo>
                  <a:lnTo>
                    <a:pt x="6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2198520" y="1425600"/>
              <a:ext cx="1620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2238480" y="1397160"/>
              <a:ext cx="15840" cy="1872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2286000" y="1366920"/>
              <a:ext cx="9360" cy="111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2286000" y="1357200"/>
              <a:ext cx="17640" cy="2088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6"/>
                  </a:moveTo>
                  <a:lnTo>
                    <a:pt x="6" y="0"/>
                  </a:lnTo>
                  <a:lnTo>
                    <a:pt x="11" y="6"/>
                  </a:lnTo>
                  <a:lnTo>
                    <a:pt x="6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2335320" y="132876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2374920" y="1298520"/>
              <a:ext cx="17280" cy="2052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7"/>
                  </a:moveTo>
                  <a:lnTo>
                    <a:pt x="11" y="0"/>
                  </a:lnTo>
                  <a:lnTo>
                    <a:pt x="11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2416320" y="127008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5" y="0"/>
                  </a:lnTo>
                  <a:lnTo>
                    <a:pt x="10" y="6"/>
                  </a:lnTo>
                  <a:lnTo>
                    <a:pt x="5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2463840" y="1241280"/>
              <a:ext cx="1728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6"/>
                  </a:moveTo>
                  <a:lnTo>
                    <a:pt x="11" y="0"/>
                  </a:lnTo>
                  <a:lnTo>
                    <a:pt x="11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2513160" y="1220760"/>
              <a:ext cx="15840" cy="2052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3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2552760" y="1201680"/>
              <a:ext cx="1728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6"/>
                  </a:moveTo>
                  <a:lnTo>
                    <a:pt x="11" y="0"/>
                  </a:lnTo>
                  <a:lnTo>
                    <a:pt x="11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2602080" y="118260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2649600" y="1162080"/>
              <a:ext cx="17280" cy="20520"/>
            </a:xfrm>
            <a:custGeom>
              <a:avLst/>
              <a:gdLst/>
              <a:ahLst/>
              <a:rect l="l" t="t" r="r" b="b"/>
              <a:pathLst>
                <a:path w="11" h="13">
                  <a:moveTo>
                    <a:pt x="0" y="7"/>
                  </a:moveTo>
                  <a:lnTo>
                    <a:pt x="11" y="0"/>
                  </a:lnTo>
                  <a:lnTo>
                    <a:pt x="11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2698920" y="1143000"/>
              <a:ext cx="1584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2746440" y="1123920"/>
              <a:ext cx="1728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6"/>
                  </a:moveTo>
                  <a:lnTo>
                    <a:pt x="11" y="0"/>
                  </a:lnTo>
                  <a:lnTo>
                    <a:pt x="11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2795760" y="111456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2844720" y="1093680"/>
              <a:ext cx="15840" cy="2088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10" y="0"/>
                  </a:lnTo>
                  <a:lnTo>
                    <a:pt x="10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2892600" y="108432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2932200" y="1065240"/>
              <a:ext cx="17280" cy="19080"/>
            </a:xfrm>
            <a:custGeom>
              <a:avLst/>
              <a:gdLst/>
              <a:ahLst/>
              <a:rect l="l" t="t" r="r" b="b"/>
              <a:pathLst>
                <a:path w="11" h="12">
                  <a:moveTo>
                    <a:pt x="0" y="6"/>
                  </a:moveTo>
                  <a:lnTo>
                    <a:pt x="11" y="0"/>
                  </a:lnTo>
                  <a:lnTo>
                    <a:pt x="11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2981160" y="1055520"/>
              <a:ext cx="1620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3030480" y="1036800"/>
              <a:ext cx="15840" cy="1872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080" bIns="-28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3078000" y="1027080"/>
              <a:ext cx="16200" cy="19080"/>
            </a:xfrm>
            <a:custGeom>
              <a:avLst/>
              <a:gdLst/>
              <a:ahLst/>
              <a:rect l="l" t="t" r="r" b="b"/>
              <a:pathLst>
                <a:path w="10" h="12">
                  <a:moveTo>
                    <a:pt x="0" y="6"/>
                  </a:moveTo>
                  <a:lnTo>
                    <a:pt x="10" y="0"/>
                  </a:lnTo>
                  <a:lnTo>
                    <a:pt x="10" y="6"/>
                  </a:lnTo>
                  <a:lnTo>
                    <a:pt x="0" y="12"/>
                  </a:lnTo>
                  <a:lnTo>
                    <a:pt x="0" y="6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3127320" y="1015920"/>
              <a:ext cx="15840" cy="20880"/>
            </a:xfrm>
            <a:custGeom>
              <a:avLst/>
              <a:gdLst/>
              <a:ahLst/>
              <a:rect l="l" t="t" r="r" b="b"/>
              <a:pathLst>
                <a:path w="10" h="13">
                  <a:moveTo>
                    <a:pt x="0" y="7"/>
                  </a:moveTo>
                  <a:lnTo>
                    <a:pt x="10" y="0"/>
                  </a:lnTo>
                  <a:lnTo>
                    <a:pt x="10" y="7"/>
                  </a:lnTo>
                  <a:lnTo>
                    <a:pt x="0" y="13"/>
                  </a:lnTo>
                  <a:lnTo>
                    <a:pt x="0" y="7"/>
                  </a:lnTo>
                  <a:close/>
                </a:path>
              </a:pathLst>
            </a:cu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3174840" y="1015920"/>
              <a:ext cx="16200" cy="111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3224160" y="100656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3271680" y="996840"/>
              <a:ext cx="1620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3321000" y="98748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3368520" y="987480"/>
              <a:ext cx="1620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3417840" y="97776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3465360" y="977760"/>
              <a:ext cx="1620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3514680" y="97776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3562200" y="968400"/>
              <a:ext cx="176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3611520" y="96840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3659040" y="968400"/>
              <a:ext cx="176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3708360" y="968400"/>
              <a:ext cx="158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3755880" y="968400"/>
              <a:ext cx="17640" cy="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3805200" y="95868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3854520" y="95868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3902040" y="95868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3951360" y="95868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3998880" y="95868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4048200" y="95868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409572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414504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419256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424188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428940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433872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438624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443556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4483080" y="947880"/>
              <a:ext cx="176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453240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4579920" y="947880"/>
              <a:ext cx="176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462924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4676760" y="947880"/>
              <a:ext cx="176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4726080" y="947880"/>
              <a:ext cx="15840" cy="108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0" bIns="-36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4761000" y="942840"/>
              <a:ext cx="15840" cy="111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1836720" y="3311640"/>
              <a:ext cx="633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1852560" y="311616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1868400" y="300024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1892160" y="283356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1925640" y="2706840"/>
              <a:ext cx="63360" cy="7920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1949400" y="260028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1981080" y="251316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2014560" y="2424240"/>
              <a:ext cx="63360" cy="7920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2038320" y="2355840"/>
              <a:ext cx="65160" cy="795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720" bIns="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2070000" y="2287440"/>
              <a:ext cx="65160" cy="795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720" bIns="9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2103480" y="2220840"/>
              <a:ext cx="633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2127240" y="216216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2158920" y="211284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2184480" y="2063880"/>
              <a:ext cx="633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2216160" y="201600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2247840" y="196704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2271600" y="192708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2417760" y="174312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2571840" y="1596960"/>
              <a:ext cx="633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2716200" y="146988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3006720" y="1293840"/>
              <a:ext cx="65160" cy="7920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3298680" y="1157400"/>
              <a:ext cx="63720" cy="7920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360" bIns="9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3589200" y="1069920"/>
              <a:ext cx="6372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3879720" y="100188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4178160" y="95400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4468680" y="923760"/>
              <a:ext cx="65160" cy="7812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4614840" y="914400"/>
              <a:ext cx="651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4761000" y="914400"/>
              <a:ext cx="633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1836720" y="331164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1852560" y="330192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1868400" y="329256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1892160" y="326232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1925640" y="321480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1949400" y="3174840"/>
              <a:ext cx="65160" cy="7812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1981080" y="311616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2014560" y="306864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2038320" y="301932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2070000" y="297036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2103480" y="2911320"/>
              <a:ext cx="63360" cy="7812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2127240" y="286380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2158920" y="2814480"/>
              <a:ext cx="65160" cy="7812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2184480" y="276552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2216160" y="2717640"/>
              <a:ext cx="65160" cy="7812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2247840" y="267804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2271600" y="26290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2417760" y="2424240"/>
              <a:ext cx="65160" cy="79200"/>
            </a:xfrm>
            <a:custGeom>
              <a:avLst/>
              <a:gdLst/>
              <a:ahLst/>
              <a:rect l="l" t="t" r="r" b="b"/>
              <a:pathLst>
                <a:path w="41" h="50">
                  <a:moveTo>
                    <a:pt x="20" y="0"/>
                  </a:moveTo>
                  <a:lnTo>
                    <a:pt x="41" y="25"/>
                  </a:lnTo>
                  <a:lnTo>
                    <a:pt x="20" y="50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2571840" y="225900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2716200" y="211284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3006720" y="18892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4"/>
                  </a:lnTo>
                  <a:lnTo>
                    <a:pt x="21" y="49"/>
                  </a:lnTo>
                  <a:lnTo>
                    <a:pt x="0" y="24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3298680" y="1712880"/>
              <a:ext cx="6372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3589200" y="1576440"/>
              <a:ext cx="63720" cy="79200"/>
            </a:xfrm>
            <a:custGeom>
              <a:avLst/>
              <a:gdLst/>
              <a:ahLst/>
              <a:rect l="l" t="t" r="r" b="b"/>
              <a:pathLst>
                <a:path w="40" h="50">
                  <a:moveTo>
                    <a:pt x="20" y="0"/>
                  </a:moveTo>
                  <a:lnTo>
                    <a:pt x="40" y="25"/>
                  </a:lnTo>
                  <a:lnTo>
                    <a:pt x="20" y="50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3879720" y="1450800"/>
              <a:ext cx="65160" cy="7812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4178160" y="134316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4468680" y="12160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4614840" y="11476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4761000" y="91440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1836720" y="331164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1852560" y="204480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1868400" y="19270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1892160" y="180180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4"/>
                  </a:lnTo>
                  <a:lnTo>
                    <a:pt x="21" y="49"/>
                  </a:lnTo>
                  <a:lnTo>
                    <a:pt x="0" y="24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1925640" y="1722600"/>
              <a:ext cx="63360" cy="79200"/>
            </a:xfrm>
            <a:custGeom>
              <a:avLst/>
              <a:gdLst/>
              <a:ahLst/>
              <a:rect l="l" t="t" r="r" b="b"/>
              <a:pathLst>
                <a:path w="40" h="50">
                  <a:moveTo>
                    <a:pt x="20" y="0"/>
                  </a:moveTo>
                  <a:lnTo>
                    <a:pt x="40" y="25"/>
                  </a:lnTo>
                  <a:lnTo>
                    <a:pt x="20" y="50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1949400" y="166536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1981080" y="16066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4"/>
                  </a:lnTo>
                  <a:lnTo>
                    <a:pt x="21" y="49"/>
                  </a:lnTo>
                  <a:lnTo>
                    <a:pt x="0" y="24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2014560" y="156672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"/>
            <p:cNvSpPr/>
            <p:nvPr/>
          </p:nvSpPr>
          <p:spPr>
            <a:xfrm>
              <a:off x="2038320" y="152892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"/>
            <p:cNvSpPr/>
            <p:nvPr/>
          </p:nvSpPr>
          <p:spPr>
            <a:xfrm>
              <a:off x="2070000" y="148896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"/>
            <p:cNvSpPr/>
            <p:nvPr/>
          </p:nvSpPr>
          <p:spPr>
            <a:xfrm>
              <a:off x="2103480" y="146052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"/>
            <p:cNvSpPr/>
            <p:nvPr/>
          </p:nvSpPr>
          <p:spPr>
            <a:xfrm>
              <a:off x="2127240" y="14302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2158920" y="140184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4"/>
                  </a:lnTo>
                  <a:lnTo>
                    <a:pt x="21" y="49"/>
                  </a:lnTo>
                  <a:lnTo>
                    <a:pt x="0" y="24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"/>
            <p:cNvSpPr/>
            <p:nvPr/>
          </p:nvSpPr>
          <p:spPr>
            <a:xfrm>
              <a:off x="2184480" y="138276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"/>
            <p:cNvSpPr/>
            <p:nvPr/>
          </p:nvSpPr>
          <p:spPr>
            <a:xfrm>
              <a:off x="2216160" y="135252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"/>
            <p:cNvSpPr/>
            <p:nvPr/>
          </p:nvSpPr>
          <p:spPr>
            <a:xfrm>
              <a:off x="2247840" y="133344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"/>
            <p:cNvSpPr/>
            <p:nvPr/>
          </p:nvSpPr>
          <p:spPr>
            <a:xfrm>
              <a:off x="2271600" y="131436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4"/>
                  </a:lnTo>
                  <a:lnTo>
                    <a:pt x="21" y="49"/>
                  </a:lnTo>
                  <a:lnTo>
                    <a:pt x="0" y="24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"/>
            <p:cNvSpPr/>
            <p:nvPr/>
          </p:nvSpPr>
          <p:spPr>
            <a:xfrm>
              <a:off x="2417760" y="12160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"/>
            <p:cNvSpPr/>
            <p:nvPr/>
          </p:nvSpPr>
          <p:spPr>
            <a:xfrm>
              <a:off x="2571840" y="114768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"/>
            <p:cNvSpPr/>
            <p:nvPr/>
          </p:nvSpPr>
          <p:spPr>
            <a:xfrm>
              <a:off x="2716200" y="1089000"/>
              <a:ext cx="65160" cy="79560"/>
            </a:xfrm>
            <a:custGeom>
              <a:avLst/>
              <a:gdLst/>
              <a:ahLst/>
              <a:rect l="l" t="t" r="r" b="b"/>
              <a:pathLst>
                <a:path w="41" h="50">
                  <a:moveTo>
                    <a:pt x="21" y="0"/>
                  </a:moveTo>
                  <a:lnTo>
                    <a:pt x="41" y="25"/>
                  </a:lnTo>
                  <a:lnTo>
                    <a:pt x="21" y="50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"/>
            <p:cNvSpPr/>
            <p:nvPr/>
          </p:nvSpPr>
          <p:spPr>
            <a:xfrm>
              <a:off x="3006720" y="100188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"/>
            <p:cNvSpPr/>
            <p:nvPr/>
          </p:nvSpPr>
          <p:spPr>
            <a:xfrm>
              <a:off x="3298680" y="954000"/>
              <a:ext cx="6372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4"/>
                  </a:lnTo>
                  <a:lnTo>
                    <a:pt x="20" y="49"/>
                  </a:lnTo>
                  <a:lnTo>
                    <a:pt x="0" y="24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"/>
            <p:cNvSpPr/>
            <p:nvPr/>
          </p:nvSpPr>
          <p:spPr>
            <a:xfrm>
              <a:off x="3589200" y="933480"/>
              <a:ext cx="6372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"/>
            <p:cNvSpPr/>
            <p:nvPr/>
          </p:nvSpPr>
          <p:spPr>
            <a:xfrm>
              <a:off x="3879720" y="923760"/>
              <a:ext cx="65160" cy="7812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1320" bIns="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"/>
            <p:cNvSpPr/>
            <p:nvPr/>
          </p:nvSpPr>
          <p:spPr>
            <a:xfrm>
              <a:off x="4178160" y="91440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"/>
            <p:cNvSpPr/>
            <p:nvPr/>
          </p:nvSpPr>
          <p:spPr>
            <a:xfrm>
              <a:off x="4468680" y="91440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1" y="0"/>
                  </a:moveTo>
                  <a:lnTo>
                    <a:pt x="41" y="25"/>
                  </a:lnTo>
                  <a:lnTo>
                    <a:pt x="21" y="49"/>
                  </a:lnTo>
                  <a:lnTo>
                    <a:pt x="0" y="25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"/>
            <p:cNvSpPr/>
            <p:nvPr/>
          </p:nvSpPr>
          <p:spPr>
            <a:xfrm>
              <a:off x="4614840" y="914400"/>
              <a:ext cx="65160" cy="77760"/>
            </a:xfrm>
            <a:custGeom>
              <a:avLst/>
              <a:gdLst/>
              <a:ahLst/>
              <a:rect l="l" t="t" r="r" b="b"/>
              <a:pathLst>
                <a:path w="41" h="49">
                  <a:moveTo>
                    <a:pt x="20" y="0"/>
                  </a:moveTo>
                  <a:lnTo>
                    <a:pt x="41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"/>
            <p:cNvSpPr/>
            <p:nvPr/>
          </p:nvSpPr>
          <p:spPr>
            <a:xfrm>
              <a:off x="4761000" y="91440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"/>
            <p:cNvSpPr/>
            <p:nvPr/>
          </p:nvSpPr>
          <p:spPr>
            <a:xfrm>
              <a:off x="1690560" y="3262320"/>
              <a:ext cx="921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"/>
            <p:cNvSpPr/>
            <p:nvPr/>
          </p:nvSpPr>
          <p:spPr>
            <a:xfrm>
              <a:off x="1578240" y="301932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"/>
            <p:cNvSpPr/>
            <p:nvPr/>
          </p:nvSpPr>
          <p:spPr>
            <a:xfrm>
              <a:off x="1578240" y="278604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"/>
            <p:cNvSpPr/>
            <p:nvPr/>
          </p:nvSpPr>
          <p:spPr>
            <a:xfrm>
              <a:off x="1578240" y="254160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3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"/>
            <p:cNvSpPr/>
            <p:nvPr/>
          </p:nvSpPr>
          <p:spPr>
            <a:xfrm>
              <a:off x="1578240" y="230832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"/>
            <p:cNvSpPr/>
            <p:nvPr/>
          </p:nvSpPr>
          <p:spPr>
            <a:xfrm>
              <a:off x="1578240" y="206388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"/>
            <p:cNvSpPr/>
            <p:nvPr/>
          </p:nvSpPr>
          <p:spPr>
            <a:xfrm>
              <a:off x="1578240" y="182088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"/>
            <p:cNvSpPr/>
            <p:nvPr/>
          </p:nvSpPr>
          <p:spPr>
            <a:xfrm>
              <a:off x="1578240" y="158760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7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"/>
            <p:cNvSpPr/>
            <p:nvPr/>
          </p:nvSpPr>
          <p:spPr>
            <a:xfrm>
              <a:off x="1578240" y="134316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"/>
            <p:cNvSpPr/>
            <p:nvPr/>
          </p:nvSpPr>
          <p:spPr>
            <a:xfrm>
              <a:off x="1578240" y="110952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9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"/>
            <p:cNvSpPr/>
            <p:nvPr/>
          </p:nvSpPr>
          <p:spPr>
            <a:xfrm>
              <a:off x="1690560" y="865080"/>
              <a:ext cx="921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"/>
            <p:cNvSpPr/>
            <p:nvPr/>
          </p:nvSpPr>
          <p:spPr>
            <a:xfrm>
              <a:off x="1836720" y="3506760"/>
              <a:ext cx="921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"/>
            <p:cNvSpPr/>
            <p:nvPr/>
          </p:nvSpPr>
          <p:spPr>
            <a:xfrm>
              <a:off x="2360880" y="350676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"/>
            <p:cNvSpPr/>
            <p:nvPr/>
          </p:nvSpPr>
          <p:spPr>
            <a:xfrm>
              <a:off x="2951640" y="350676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"/>
            <p:cNvSpPr/>
            <p:nvPr/>
          </p:nvSpPr>
          <p:spPr>
            <a:xfrm>
              <a:off x="3532680" y="350676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"/>
            <p:cNvSpPr/>
            <p:nvPr/>
          </p:nvSpPr>
          <p:spPr>
            <a:xfrm>
              <a:off x="4123080" y="3506760"/>
              <a:ext cx="22932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"/>
            <p:cNvSpPr/>
            <p:nvPr/>
          </p:nvSpPr>
          <p:spPr>
            <a:xfrm>
              <a:off x="4761000" y="3506760"/>
              <a:ext cx="921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3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"/>
            <p:cNvSpPr/>
            <p:nvPr/>
          </p:nvSpPr>
          <p:spPr>
            <a:xfrm>
              <a:off x="2641680" y="3798720"/>
              <a:ext cx="173808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False positive fraction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"/>
            <p:cNvSpPr/>
            <p:nvPr/>
          </p:nvSpPr>
          <p:spPr>
            <a:xfrm rot="16200000">
              <a:off x="574920" y="1889640"/>
              <a:ext cx="167400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True positive fraction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3" name=""/>
            <p:cNvGrpSpPr/>
            <p:nvPr/>
          </p:nvGrpSpPr>
          <p:grpSpPr>
            <a:xfrm>
              <a:off x="4149720" y="2000160"/>
              <a:ext cx="1610280" cy="425880"/>
              <a:chOff x="4149720" y="2000160"/>
              <a:chExt cx="1610280" cy="425880"/>
            </a:xfrm>
          </p:grpSpPr>
          <p:sp>
            <p:nvSpPr>
              <p:cNvPr id="654" name=""/>
              <p:cNvSpPr/>
              <p:nvPr/>
            </p:nvSpPr>
            <p:spPr>
              <a:xfrm>
                <a:off x="4149720" y="2087640"/>
                <a:ext cx="403200" cy="1440"/>
              </a:xfrm>
              <a:prstGeom prst="line">
                <a:avLst/>
              </a:prstGeom>
              <a:ln w="7920">
                <a:solidFill>
                  <a:srgbClr val="0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5" name=""/>
              <p:cNvSpPr/>
              <p:nvPr/>
            </p:nvSpPr>
            <p:spPr>
              <a:xfrm>
                <a:off x="4319640" y="2049480"/>
                <a:ext cx="63360" cy="77760"/>
              </a:xfrm>
              <a:prstGeom prst="ellipse">
                <a:avLst/>
              </a:prstGeom>
              <a:solidFill>
                <a:srgbClr val="000080"/>
              </a:solidFill>
              <a:ln w="7920">
                <a:solidFill>
                  <a:srgbClr val="0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>
                <a:off x="4579560" y="2000160"/>
                <a:ext cx="11804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itted ROC curv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7" name=""/>
              <p:cNvSpPr/>
              <p:nvPr/>
            </p:nvSpPr>
            <p:spPr>
              <a:xfrm>
                <a:off x="4149720" y="2322360"/>
                <a:ext cx="158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8" name=""/>
              <p:cNvSpPr/>
              <p:nvPr/>
            </p:nvSpPr>
            <p:spPr>
              <a:xfrm>
                <a:off x="4197240" y="2322360"/>
                <a:ext cx="158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"/>
              <p:cNvSpPr/>
              <p:nvPr/>
            </p:nvSpPr>
            <p:spPr>
              <a:xfrm>
                <a:off x="4246560" y="2322360"/>
                <a:ext cx="158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"/>
              <p:cNvSpPr/>
              <p:nvPr/>
            </p:nvSpPr>
            <p:spPr>
              <a:xfrm>
                <a:off x="4294080" y="2322360"/>
                <a:ext cx="176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>
                <a:off x="4343400" y="2322360"/>
                <a:ext cx="158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2" name=""/>
              <p:cNvSpPr/>
              <p:nvPr/>
            </p:nvSpPr>
            <p:spPr>
              <a:xfrm>
                <a:off x="4390920" y="2322360"/>
                <a:ext cx="176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3" name=""/>
              <p:cNvSpPr/>
              <p:nvPr/>
            </p:nvSpPr>
            <p:spPr>
              <a:xfrm>
                <a:off x="4440240" y="2322360"/>
                <a:ext cx="158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4" name=""/>
              <p:cNvSpPr/>
              <p:nvPr/>
            </p:nvSpPr>
            <p:spPr>
              <a:xfrm>
                <a:off x="4487760" y="2322360"/>
                <a:ext cx="176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5" name=""/>
              <p:cNvSpPr/>
              <p:nvPr/>
            </p:nvSpPr>
            <p:spPr>
              <a:xfrm>
                <a:off x="4537080" y="2322360"/>
                <a:ext cx="158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>
                <a:off x="4319640" y="2292480"/>
                <a:ext cx="63360" cy="77760"/>
              </a:xfrm>
              <a:custGeom>
                <a:avLst/>
                <a:gdLst/>
                <a:ahLst/>
                <a:rect l="l" t="t" r="r" b="b"/>
                <a:pathLst>
                  <a:path w="40" h="49">
                    <a:moveTo>
                      <a:pt x="20" y="0"/>
                    </a:moveTo>
                    <a:lnTo>
                      <a:pt x="40" y="25"/>
                    </a:lnTo>
                    <a:lnTo>
                      <a:pt x="20" y="49"/>
                    </a:lnTo>
                    <a:lnTo>
                      <a:pt x="0" y="25"/>
                    </a:lnTo>
                    <a:lnTo>
                      <a:pt x="20" y="0"/>
                    </a:lnTo>
                    <a:close/>
                  </a:path>
                </a:pathLst>
              </a:custGeom>
              <a:solidFill>
                <a:srgbClr val="808080"/>
              </a:solidFill>
              <a:ln w="7920">
                <a:solidFill>
                  <a:srgbClr val="80808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7" name=""/>
              <p:cNvSpPr/>
              <p:nvPr/>
            </p:nvSpPr>
            <p:spPr>
              <a:xfrm>
                <a:off x="4584960" y="2243160"/>
                <a:ext cx="890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95% CI limit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8" name=""/>
              <p:cNvSpPr/>
              <p:nvPr/>
            </p:nvSpPr>
            <p:spPr>
              <a:xfrm>
                <a:off x="5045040" y="2360520"/>
                <a:ext cx="176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>
                <a:off x="5438880" y="2360520"/>
                <a:ext cx="15840" cy="972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70" name=""/>
            <p:cNvSpPr/>
            <p:nvPr/>
          </p:nvSpPr>
          <p:spPr>
            <a:xfrm>
              <a:off x="2996640" y="488880"/>
              <a:ext cx="826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igure 3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1" name=""/>
          <p:cNvSpPr/>
          <p:nvPr/>
        </p:nvSpPr>
        <p:spPr>
          <a:xfrm>
            <a:off x="3212280" y="5313240"/>
            <a:ext cx="82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3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2" name=""/>
          <p:cNvGrpSpPr/>
          <p:nvPr/>
        </p:nvGrpSpPr>
        <p:grpSpPr>
          <a:xfrm>
            <a:off x="4292640" y="6753240"/>
            <a:ext cx="1610280" cy="425880"/>
            <a:chOff x="4292640" y="6753240"/>
            <a:chExt cx="1610280" cy="425880"/>
          </a:xfrm>
        </p:grpSpPr>
        <p:sp>
          <p:nvSpPr>
            <p:cNvPr id="673" name=""/>
            <p:cNvSpPr/>
            <p:nvPr/>
          </p:nvSpPr>
          <p:spPr>
            <a:xfrm>
              <a:off x="4292640" y="6840720"/>
              <a:ext cx="403200" cy="1440"/>
            </a:xfrm>
            <a:prstGeom prst="line">
              <a:avLst/>
            </a:prstGeom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"/>
            <p:cNvSpPr/>
            <p:nvPr/>
          </p:nvSpPr>
          <p:spPr>
            <a:xfrm>
              <a:off x="4462560" y="6802560"/>
              <a:ext cx="63360" cy="77760"/>
            </a:xfrm>
            <a:prstGeom prst="ellipse">
              <a:avLst/>
            </a:prstGeom>
            <a:solidFill>
              <a:srgbClr val="000080"/>
            </a:solidFill>
            <a:ln w="792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"/>
            <p:cNvSpPr/>
            <p:nvPr/>
          </p:nvSpPr>
          <p:spPr>
            <a:xfrm>
              <a:off x="4722480" y="6753240"/>
              <a:ext cx="1180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Fitted ROC curv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"/>
            <p:cNvSpPr/>
            <p:nvPr/>
          </p:nvSpPr>
          <p:spPr>
            <a:xfrm>
              <a:off x="4292640" y="707544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"/>
            <p:cNvSpPr/>
            <p:nvPr/>
          </p:nvSpPr>
          <p:spPr>
            <a:xfrm>
              <a:off x="4340160" y="707544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"/>
            <p:cNvSpPr/>
            <p:nvPr/>
          </p:nvSpPr>
          <p:spPr>
            <a:xfrm>
              <a:off x="4389480" y="707544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"/>
            <p:cNvSpPr/>
            <p:nvPr/>
          </p:nvSpPr>
          <p:spPr>
            <a:xfrm>
              <a:off x="4437000" y="7075440"/>
              <a:ext cx="176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"/>
            <p:cNvSpPr/>
            <p:nvPr/>
          </p:nvSpPr>
          <p:spPr>
            <a:xfrm>
              <a:off x="4486320" y="707544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"/>
            <p:cNvSpPr/>
            <p:nvPr/>
          </p:nvSpPr>
          <p:spPr>
            <a:xfrm>
              <a:off x="4533840" y="7075440"/>
              <a:ext cx="176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"/>
            <p:cNvSpPr/>
            <p:nvPr/>
          </p:nvSpPr>
          <p:spPr>
            <a:xfrm>
              <a:off x="4583160" y="707544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"/>
            <p:cNvSpPr/>
            <p:nvPr/>
          </p:nvSpPr>
          <p:spPr>
            <a:xfrm>
              <a:off x="4630680" y="7075440"/>
              <a:ext cx="176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"/>
            <p:cNvSpPr/>
            <p:nvPr/>
          </p:nvSpPr>
          <p:spPr>
            <a:xfrm>
              <a:off x="4680000" y="707544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"/>
            <p:cNvSpPr/>
            <p:nvPr/>
          </p:nvSpPr>
          <p:spPr>
            <a:xfrm>
              <a:off x="4462560" y="7045560"/>
              <a:ext cx="63360" cy="77760"/>
            </a:xfrm>
            <a:custGeom>
              <a:avLst/>
              <a:gdLst/>
              <a:ahLst/>
              <a:rect l="l" t="t" r="r" b="b"/>
              <a:pathLst>
                <a:path w="40" h="49">
                  <a:moveTo>
                    <a:pt x="20" y="0"/>
                  </a:moveTo>
                  <a:lnTo>
                    <a:pt x="40" y="25"/>
                  </a:lnTo>
                  <a:lnTo>
                    <a:pt x="20" y="49"/>
                  </a:lnTo>
                  <a:lnTo>
                    <a:pt x="0" y="25"/>
                  </a:lnTo>
                  <a:lnTo>
                    <a:pt x="20" y="0"/>
                  </a:lnTo>
                  <a:close/>
                </a:path>
              </a:pathLst>
            </a:custGeom>
            <a:solidFill>
              <a:srgbClr val="808080"/>
            </a:solidFill>
            <a:ln w="792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"/>
            <p:cNvSpPr/>
            <p:nvPr/>
          </p:nvSpPr>
          <p:spPr>
            <a:xfrm>
              <a:off x="4727880" y="6996240"/>
              <a:ext cx="8906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95% CI limit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"/>
            <p:cNvSpPr/>
            <p:nvPr/>
          </p:nvSpPr>
          <p:spPr>
            <a:xfrm>
              <a:off x="5187960" y="7113600"/>
              <a:ext cx="176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"/>
            <p:cNvSpPr/>
            <p:nvPr/>
          </p:nvSpPr>
          <p:spPr>
            <a:xfrm>
              <a:off x="5581800" y="7113600"/>
              <a:ext cx="15840" cy="972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12-10T11:34:58Z</dcterms:created>
  <dc:creator>Anne Chang</dc:creator>
  <dc:description/>
  <dc:language>en-US</dc:language>
  <cp:lastModifiedBy>Anne Chang</cp:lastModifiedBy>
  <dcterms:modified xsi:type="dcterms:W3CDTF">2004-12-10T14:21:17Z</dcterms:modified>
  <cp:revision>6</cp:revision>
  <dc:subject/>
  <dc:title>Slide 1</dc:title>
</cp:coreProperties>
</file>